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3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DC3C88-5D70-47EC-B2B7-5012C44CAF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F6511B-AF20-4B23-B29C-7D9B76372F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434C6B-D9F3-451C-8BC5-B52BE09ED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77827-783A-4324-B728-A8860ABE5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783888-DD77-46CD-BE8D-25461D716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86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BBF56-1693-49D7-A791-C5CA445E5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631125-2057-4CA1-8644-A4E5B3BC73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FE49A0-A1FD-4DD5-B786-295A52FEA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D5096C-3F6F-48AF-AF35-44F66E17E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73207C-AD08-48EB-BE59-1839BA69B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017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B2FF32-021A-4333-8ABC-90BFE853BF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6435F9-407A-4A81-889A-5A8D5EA8D0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228251-CE3C-44D4-962E-6DE8BE6BA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326EB9-59B7-43AC-AF2A-B7AB9B5E2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F548C7-AB66-4DC9-B130-C450D9A47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912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D4BD3C-8EDF-4562-837D-7E7D6105DF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E847F0-AF1F-4084-80F8-215889F7D0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F9C0D-0E02-4BED-8105-7C0081327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A1C82-752B-49C7-8927-2DE9D6A9F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1ED168-876D-49E9-8B3A-455899C13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158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6EA9AC-2DA4-43DF-BAA5-38071E3553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B85200-F21B-4C67-86F7-7F826DED97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03B3FE-354A-434A-A1DD-94DDAA021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2FE98D-1A5D-4EDB-A3A8-3FAFC9F31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028A35-41D3-4470-8D8E-17EC4CF22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317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C714AF-CE91-49AC-9F17-A76882DD3D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E0652F-7D82-413B-A6B4-F9F687EEC3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D68FDF-EE9D-4FD4-A791-0471745C16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B924F5-E19F-4684-A590-ACB3F2D3C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9CBA9C-0EA6-4BCB-8872-EE1F3AD03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A8989B-7498-44D9-9242-D9A306D66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108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41A889-9F09-49B1-86BA-F94ECCB1EF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9DAD9E-6DD1-416A-8D67-F30E04F149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03AE9E-209D-4A1F-9EE2-805822684C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7697FD-042E-4DE2-A016-A5FE3F69DC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E1F4E58-9980-4B97-B9C2-123B907229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35B38F-8D6B-4BFA-9371-5E7974215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E83723-77DC-4638-91EC-2FDA7E1FF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6BCEAC-8B2F-4CF3-8A89-351E2678F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175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01481-0052-4B91-9FF9-116D7BBCFB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833570-CD39-44E4-9ED3-A92E0ACC3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5FFBBA-1096-413A-A203-4BF0694F6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CCE8CB-CA33-4320-9C1C-67B4B2C73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153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33C521-3412-4F68-A846-5A0E4C8A0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13537C-D1B6-403E-B361-53EAA34F2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31CA45-67D7-47BB-803B-BDC936DDC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865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62197-3AA3-4415-BD5B-01A9467EB9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B041A4-8145-4712-8152-4933F12ADF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E7E97F-B973-4668-8675-CD16062DB4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048BD8-977C-4070-87A4-5096C1DAA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A22905-4668-40D6-A797-74BB850E1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63B7E5-921E-4370-844B-DA1D7A5C2D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61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28CD80-F900-4EB8-81E8-4298357E7A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97D1F2-5A66-491A-BBB1-93CFDA74F2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7ECFF9-7E3B-4B38-A85F-24E2AD66C8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EE294C-7B9E-4194-83F6-2E574AB89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B8F02E-F826-446F-A715-50EDAF12D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AC2B1F-61BD-4056-8D48-2FD5FB97D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904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0BDC21-4AEF-4EB7-811E-CE65C5DAE6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A22268-5E16-4F88-8916-BB645DB1F9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D95D8E-741D-4AF3-8E8C-10B5514108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C05376-66E4-4C33-A81F-D8CED17D9667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4A4F3D-CD86-4E2B-9B06-E20282FEE1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15AD94-1B42-43EB-94DB-21C4241DBE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CF123-B1F0-4916-A337-C724349D7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329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3B7AAFD1-C744-871C-4BA1-DDE35AEE07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5272690"/>
              </p:ext>
            </p:extLst>
          </p:nvPr>
        </p:nvGraphicFramePr>
        <p:xfrm>
          <a:off x="1736332" y="403049"/>
          <a:ext cx="7304926" cy="548598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01054">
                  <a:extLst>
                    <a:ext uri="{9D8B030D-6E8A-4147-A177-3AD203B41FA5}">
                      <a16:colId xmlns:a16="http://schemas.microsoft.com/office/drawing/2014/main" val="275413141"/>
                    </a:ext>
                  </a:extLst>
                </a:gridCol>
                <a:gridCol w="1904230">
                  <a:extLst>
                    <a:ext uri="{9D8B030D-6E8A-4147-A177-3AD203B41FA5}">
                      <a16:colId xmlns:a16="http://schemas.microsoft.com/office/drawing/2014/main" val="2588098818"/>
                    </a:ext>
                  </a:extLst>
                </a:gridCol>
                <a:gridCol w="1953982">
                  <a:extLst>
                    <a:ext uri="{9D8B030D-6E8A-4147-A177-3AD203B41FA5}">
                      <a16:colId xmlns:a16="http://schemas.microsoft.com/office/drawing/2014/main" val="3199821"/>
                    </a:ext>
                  </a:extLst>
                </a:gridCol>
                <a:gridCol w="1445660">
                  <a:extLst>
                    <a:ext uri="{9D8B030D-6E8A-4147-A177-3AD203B41FA5}">
                      <a16:colId xmlns:a16="http://schemas.microsoft.com/office/drawing/2014/main" val="296105734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Variant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# of peptides in librar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Manufactur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Catalog numb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7669705"/>
                  </a:ext>
                </a:extLst>
              </a:tr>
              <a:tr h="387167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Ancestral full length S1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15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JPT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M-WCPV-S-1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74733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/>
                        <a:t>Ancestral full length S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157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JPT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M-WCPV-S-1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985475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/>
                        <a:t>Omicron full length S1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15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eptide &amp; Elephants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B02000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75332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/>
                        <a:t>Omicron full length S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157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eptide &amp; Elephants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B02000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4127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Alpha variant 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34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ltenyi Biotec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0-127-844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12857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Beta variant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30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ltenyi Biotec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0-127-958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71204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Gamma variant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41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ltenyi Biotec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0-128-48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96477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Delta variant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ltenyi Biotec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0-128-763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52601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Eta variant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2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ltenyi Biotec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0-128-483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66834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Epsilon variant 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16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ltenyi Biotec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0-128-482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1315678"/>
                  </a:ext>
                </a:extLst>
              </a:tr>
              <a:tr h="224535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Kappa variant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30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ltenyi Biotec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0-128-762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86518"/>
                  </a:ext>
                </a:extLst>
              </a:tr>
              <a:tr h="343937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Omicron variant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83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eptide &amp; Elephants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B0199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78278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Full length M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53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ltenyi Biotec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0-126-702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14364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Full length NP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10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iltenyi Biotec</a:t>
                      </a:r>
                      <a:endParaRPr lang="en-U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0-126-69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659268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02FE245-391C-0AEE-04F3-77A7B6668DB8}"/>
              </a:ext>
            </a:extLst>
          </p:cNvPr>
          <p:cNvSpPr txBox="1"/>
          <p:nvPr/>
        </p:nvSpPr>
        <p:spPr>
          <a:xfrm>
            <a:off x="244790" y="6177952"/>
            <a:ext cx="117024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 b="1"/>
            </a:lvl1pPr>
          </a:lstStyle>
          <a:p>
            <a:r>
              <a:rPr lang="en-US" sz="1200" dirty="0"/>
              <a:t>Supplementary Table 1</a:t>
            </a:r>
            <a:r>
              <a:rPr lang="en-US" sz="1200" b="0" dirty="0"/>
              <a:t>:  List of peptide libraries used in the study</a:t>
            </a:r>
          </a:p>
        </p:txBody>
      </p:sp>
    </p:spTree>
    <p:extLst>
      <p:ext uri="{BB962C8B-B14F-4D97-AF65-F5344CB8AC3E}">
        <p14:creationId xmlns:p14="http://schemas.microsoft.com/office/powerpoint/2010/main" val="736112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90</TotalTime>
  <Words>116</Words>
  <Application>Microsoft Office PowerPoint</Application>
  <PresentationFormat>Widescreen</PresentationFormat>
  <Paragraphs>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i, Mithil K.</dc:creator>
  <cp:lastModifiedBy>Miller, Maureen (NIH/CC/DTM) [E]</cp:lastModifiedBy>
  <cp:revision>32</cp:revision>
  <cp:lastPrinted>2022-12-13T17:59:45Z</cp:lastPrinted>
  <dcterms:created xsi:type="dcterms:W3CDTF">2021-10-20T20:36:09Z</dcterms:created>
  <dcterms:modified xsi:type="dcterms:W3CDTF">2023-06-06T13:18:30Z</dcterms:modified>
</cp:coreProperties>
</file>